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23A310-43C2-4A50-AFBE-7F6DFBD08B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02ACD-B34B-488D-AD44-6A25E935B0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D1CFB-2958-4028-A884-AC1381DF75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EC53E-C97B-4535-AE69-57AFA696A5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14E26A-FD41-451E-A552-9E97AD8A71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3EDA3-1BB6-46F2-9F53-4B25979B9B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5C382-D492-4A34-871D-2CC63A0B0D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05E97-F78A-42E2-9BFB-4649240CC2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B0486-9DC8-4397-BADD-CBC5993D02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0067E-F971-43D1-9F65-96824F32C9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5E35A-84D1-4AB5-92B4-7BD56A6368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EF485-672F-4DDD-9F23-1CB0F94E8E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4152D5-1D8D-4F8D-B4B9-2EBCA2B4EE1D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57200" y="981000"/>
          <a:ext cx="8229600" cy="4329360"/>
        </p:xfrm>
        <a:graphic>
          <a:graphicData uri="http://schemas.openxmlformats.org/drawingml/2006/table">
            <a:tbl>
              <a:tblPr/>
              <a:tblGrid>
                <a:gridCol w="1521000"/>
                <a:gridCol w="3311280"/>
                <a:gridCol w="3397320"/>
              </a:tblGrid>
              <a:tr h="336600">
                <a:tc gridSpan="3"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ble S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 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rkers designed for Real-time PC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5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  </a:t>
                      </a: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ene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 primer (5’→3’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primer (5’→3’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OsRpoT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CCTCATGTCGAGCAAGG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AAAGAATGTCTGGACTT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tsZ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AAGGACATAACCTTGCA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TTTTCCTATTGAACCG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b1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ATGGGTTTAGTGCGACG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TTGGGATCGAGGGAGTATT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bc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TTGGCAGCATTCCGAGT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CAACGGGCTCGATGTGA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c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CCGCTGAGTTTTGGCTATT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GACTTGAGCCCTGGAAG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sb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CCTCATTAGCAGATTCGTTT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TGATTGTATTCCAGGCAGAG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o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TGGTCTAATTCCGAGC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TGGTCTAATTCCGAGC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oC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TTAGACGCATGCAATTGG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ATGGGTCTTAATTCGGGA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o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ATTTACGCGAGGGACTTT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AAGATATCCAGCATCCGC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S rRN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CGTTGGTGTTCTTTCCG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TCAAGTCCGCCGTCAAA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GTGGGCGTTAGAGCATTG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CTTGGCTACCCAGCGTT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   </a:t>
                      </a:r>
                      <a:r>
                        <a:rPr b="0" i="1" lang="zh-CN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GAAGGCTGGAAGAGGAC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4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GGGAAATTGTGAGGGAC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Administrator</dc:creator>
  <dc:description/>
  <cp:keywords/>
  <dc:language>en-US</dc:language>
  <cp:lastModifiedBy>微软用户</cp:lastModifiedBy>
  <dcterms:modified xsi:type="dcterms:W3CDTF">2014-12-07T14:04:57Z</dcterms:modified>
  <cp:revision>13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468</vt:lpwstr>
  </property>
</Properties>
</file>